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4" r:id="rId2"/>
    <p:sldId id="288" r:id="rId3"/>
    <p:sldId id="257" r:id="rId4"/>
    <p:sldId id="273" r:id="rId5"/>
    <p:sldId id="263" r:id="rId6"/>
  </p:sldIdLst>
  <p:sldSz cx="6858000" cy="12192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A8A6E2D-8737-6E38-B62F-B9D506612D3B}" name="Ghobrial, Irene M.,MD" initials="GIM" userId="S::irene_ghobrial@dfci.harvard.edu::816cfbb7-fe08-44f1-90e3-36747402e3af" providerId="AD"/>
  <p188:author id="{D0035A4C-5226-B94D-F9AA-291282A441AE}" name="Aranha, Michelle P." initials="AMP" userId="S::michellep_aranha@dfci.harvard.edu::625c2ac6-c1ae-4fe6-99d8-53715fc352ab" providerId="AD"/>
  <p188:author id="{0FED7B4C-9FE9-F5F3-715D-B0EAB2CE2388}" name="Anna Justis" initials="AJ" userId="6e438f80d966ec2b" providerId="Windows Live"/>
  <p188:author id="{13CE1475-20C1-B8C0-C8DC-3431B9C7B9C9}" name="Nadeem, Omar,MD" initials="" userId="S::Omar_Nadeem@DFCI.HARVARD.EDU::7a714cd1-7f5b-4b0f-b368-5fa1b6596306" providerId="AD"/>
  <p188:author id="{E35C75B3-E38B-089E-E489-BB1D46AB8137}" name="Aranha, Michelle P." initials="MA" userId="S::MichelleP_Aranha@DFCI.HARVARD.EDU::625c2ac6-c1ae-4fe6-99d8-53715fc352ab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ranha, Michelle P." initials="AMP" lastIdx="8" clrIdx="0">
    <p:extLst>
      <p:ext uri="{19B8F6BF-5375-455C-9EA6-DF929625EA0E}">
        <p15:presenceInfo xmlns:p15="http://schemas.microsoft.com/office/powerpoint/2012/main" userId="S::MichelleP_Aranha@DFCI.HARVARD.EDU::625c2ac6-c1ae-4fe6-99d8-53715fc352a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106"/>
    <p:restoredTop sz="83909"/>
  </p:normalViewPr>
  <p:slideViewPr>
    <p:cSldViewPr snapToGrid="0">
      <p:cViewPr varScale="1">
        <p:scale>
          <a:sx n="56" d="100"/>
          <a:sy n="56" d="100"/>
        </p:scale>
        <p:origin x="3520" y="20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DD84AD17-58F4-4542-9C6B-B83422F138D1}" type="datetimeFigureOut">
              <a:rPr lang="en-US" smtClean="0"/>
              <a:t>4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22550" y="1162050"/>
            <a:ext cx="176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8D892FF-C14E-8046-B109-1063475BC3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517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3F05B83-DE7D-AF49-8C33-65868135386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842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631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235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23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618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006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205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20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98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524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251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574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52986-28ED-C34E-B88A-824F3C018875}" type="datetimeFigureOut">
              <a:rPr lang="en-US" smtClean="0"/>
              <a:t>4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577AA-5031-6046-8696-6C15C84670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9123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D54A5-C353-7F91-D47B-37CD61572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24828" y="5723389"/>
            <a:ext cx="4414838" cy="745629"/>
          </a:xfrm>
        </p:spPr>
        <p:txBody>
          <a:bodyPr>
            <a:normAutofit/>
          </a:bodyPr>
          <a:lstStyle/>
          <a:p>
            <a:r>
              <a:rPr lang="en-US" dirty="0">
                <a:ea typeface="Calibri Light"/>
                <a:cs typeface="Calibri Light"/>
              </a:rPr>
              <a:t>Supplementary 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09430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close-up of several different colored labels&#10;&#10;Description automatically generated">
            <a:extLst>
              <a:ext uri="{FF2B5EF4-FFF2-40B4-BE49-F238E27FC236}">
                <a16:creationId xmlns:a16="http://schemas.microsoft.com/office/drawing/2014/main" id="{B0600CB1-49B1-341C-AE33-148104D4EC9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72422" y="4670707"/>
            <a:ext cx="6419648" cy="1768234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6066003-1DAF-669A-BFC2-E20DE5B6D31D}"/>
              </a:ext>
            </a:extLst>
          </p:cNvPr>
          <p:cNvSpPr txBox="1"/>
          <p:nvPr/>
        </p:nvSpPr>
        <p:spPr>
          <a:xfrm>
            <a:off x="72422" y="4224921"/>
            <a:ext cx="527420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solidFill>
                  <a:srgbClr val="000000"/>
                </a:solidFill>
                <a:latin typeface="Calibri" panose="020F0502020204030204" pitchFamily="34" charset="0"/>
              </a:rPr>
              <a:t>Figure S1. Summary of MRD testing by NGS in patients who achieved VGPR or better response.</a:t>
            </a:r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2868213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E7FB7264-7ECD-3644-51FB-9E3588218636}"/>
              </a:ext>
            </a:extLst>
          </p:cNvPr>
          <p:cNvSpPr/>
          <p:nvPr/>
        </p:nvSpPr>
        <p:spPr>
          <a:xfrm>
            <a:off x="353856" y="4494407"/>
            <a:ext cx="3858871" cy="495532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Baseline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48 out of 55 Tested</a:t>
            </a: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30D691BC-E376-EF74-47DE-F4C583233B1A}"/>
              </a:ext>
            </a:extLst>
          </p:cNvPr>
          <p:cNvSpPr/>
          <p:nvPr/>
        </p:nvSpPr>
        <p:spPr>
          <a:xfrm>
            <a:off x="1443846" y="5188849"/>
            <a:ext cx="2768881" cy="706708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End of Induction (C9)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43 out of 48 Tested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39 POS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4 NEG</a:t>
            </a: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C35A37A2-AF8A-CB81-390D-1584507BB86C}"/>
              </a:ext>
            </a:extLst>
          </p:cNvPr>
          <p:cNvSpPr/>
          <p:nvPr/>
        </p:nvSpPr>
        <p:spPr>
          <a:xfrm>
            <a:off x="2987248" y="6000016"/>
            <a:ext cx="1211041" cy="70670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During Maintenance (C11-C16)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37 out of 43 Tested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31 POS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6 NEG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F18E00C9-C7DB-B2F3-2861-B371A76B44F0}"/>
              </a:ext>
            </a:extLst>
          </p:cNvPr>
          <p:cNvSpPr/>
          <p:nvPr/>
        </p:nvSpPr>
        <p:spPr>
          <a:xfrm>
            <a:off x="1632471" y="6811185"/>
            <a:ext cx="1211041" cy="70670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End of Treatment (EOT)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4 out of 43 Tested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4 POS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0 NEG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F3895A00-0FF5-C47E-5DD8-E49ADA054D44}"/>
              </a:ext>
            </a:extLst>
          </p:cNvPr>
          <p:cNvSpPr/>
          <p:nvPr/>
        </p:nvSpPr>
        <p:spPr>
          <a:xfrm>
            <a:off x="277694" y="6811185"/>
            <a:ext cx="1211041" cy="70670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End of Treatment (EOT)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5 out of 48 Tested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4 POS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1 NEG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D18291D-AA47-3848-988D-64AA5DAA9AA1}"/>
              </a:ext>
            </a:extLst>
          </p:cNvPr>
          <p:cNvCxnSpPr>
            <a:cxnSpLocks/>
            <a:endCxn id="5" idx="0"/>
          </p:cNvCxnSpPr>
          <p:nvPr/>
        </p:nvCxnSpPr>
        <p:spPr>
          <a:xfrm>
            <a:off x="2828286" y="4989939"/>
            <a:ext cx="0" cy="19891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20F3E93-19BF-3692-4B65-98A2FAAC3342}"/>
              </a:ext>
            </a:extLst>
          </p:cNvPr>
          <p:cNvCxnSpPr>
            <a:cxnSpLocks/>
            <a:endCxn id="6" idx="0"/>
          </p:cNvCxnSpPr>
          <p:nvPr/>
        </p:nvCxnSpPr>
        <p:spPr>
          <a:xfrm>
            <a:off x="3592769" y="5893493"/>
            <a:ext cx="0" cy="106523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3163B430-6A00-E6C4-ACB2-E1C73DA949AE}"/>
              </a:ext>
            </a:extLst>
          </p:cNvPr>
          <p:cNvCxnSpPr>
            <a:cxnSpLocks/>
            <a:endCxn id="9" idx="0"/>
          </p:cNvCxnSpPr>
          <p:nvPr/>
        </p:nvCxnSpPr>
        <p:spPr>
          <a:xfrm>
            <a:off x="883214" y="4989939"/>
            <a:ext cx="0" cy="182124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2ED40E5-5AC6-2185-1984-7CE3C82A7F0A}"/>
              </a:ext>
            </a:extLst>
          </p:cNvPr>
          <p:cNvCxnSpPr>
            <a:cxnSpLocks/>
            <a:stCxn id="4" idx="3"/>
          </p:cNvCxnSpPr>
          <p:nvPr/>
        </p:nvCxnSpPr>
        <p:spPr>
          <a:xfrm>
            <a:off x="4212726" y="4742173"/>
            <a:ext cx="1207607" cy="0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F23244DA-3423-4184-1C28-D8DD744153F1}"/>
              </a:ext>
            </a:extLst>
          </p:cNvPr>
          <p:cNvSpPr/>
          <p:nvPr/>
        </p:nvSpPr>
        <p:spPr>
          <a:xfrm>
            <a:off x="5451640" y="4494407"/>
            <a:ext cx="1168530" cy="495532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75" b="1" dirty="0">
                <a:solidFill>
                  <a:schemeClr val="tx1"/>
                </a:solidFill>
              </a:rPr>
              <a:t>Excluded</a:t>
            </a:r>
          </a:p>
          <a:p>
            <a:pPr marL="160734" indent="-160734" algn="ctr">
              <a:buFontTx/>
              <a:buChar char="-"/>
            </a:pPr>
            <a:r>
              <a:rPr lang="en-US" sz="619" dirty="0">
                <a:solidFill>
                  <a:schemeClr val="tx1"/>
                </a:solidFill>
              </a:rPr>
              <a:t>n=2 Light Chain Only</a:t>
            </a:r>
          </a:p>
          <a:p>
            <a:pPr marL="160734" indent="-160734" algn="ctr">
              <a:buFontTx/>
              <a:buChar char="-"/>
            </a:pPr>
            <a:r>
              <a:rPr lang="en-US" sz="619" dirty="0">
                <a:solidFill>
                  <a:schemeClr val="tx1"/>
                </a:solidFill>
              </a:rPr>
              <a:t>n=5 Samples Not Available at Baseline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E0FC29C-B055-6033-BFDC-6FBF0AAB2B4D}"/>
              </a:ext>
            </a:extLst>
          </p:cNvPr>
          <p:cNvCxnSpPr>
            <a:cxnSpLocks/>
            <a:stCxn id="26" idx="1"/>
            <a:endCxn id="5" idx="3"/>
          </p:cNvCxnSpPr>
          <p:nvPr/>
        </p:nvCxnSpPr>
        <p:spPr>
          <a:xfrm flipH="1">
            <a:off x="4212726" y="5542203"/>
            <a:ext cx="1238914" cy="0"/>
          </a:xfrm>
          <a:prstGeom prst="line">
            <a:avLst/>
          </a:prstGeom>
          <a:ln w="19050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34D87D5B-0073-9F2A-B567-01779310EEE6}"/>
              </a:ext>
            </a:extLst>
          </p:cNvPr>
          <p:cNvSpPr/>
          <p:nvPr/>
        </p:nvSpPr>
        <p:spPr>
          <a:xfrm>
            <a:off x="5451641" y="5294437"/>
            <a:ext cx="1168530" cy="495533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75" b="1" dirty="0">
                <a:solidFill>
                  <a:schemeClr val="tx1"/>
                </a:solidFill>
              </a:rPr>
              <a:t>Excluded</a:t>
            </a:r>
          </a:p>
          <a:p>
            <a:pPr marL="160734" indent="-160734" algn="ctr">
              <a:buFontTx/>
              <a:buChar char="-"/>
            </a:pPr>
            <a:r>
              <a:rPr lang="en-US" sz="619" dirty="0">
                <a:solidFill>
                  <a:schemeClr val="tx1"/>
                </a:solidFill>
              </a:rPr>
              <a:t>n=2 Samples Not Available after C9</a:t>
            </a:r>
          </a:p>
        </p:txBody>
      </p:sp>
      <p:sp>
        <p:nvSpPr>
          <p:cNvPr id="50" name="Rounded Rectangle 49">
            <a:extLst>
              <a:ext uri="{FF2B5EF4-FFF2-40B4-BE49-F238E27FC236}">
                <a16:creationId xmlns:a16="http://schemas.microsoft.com/office/drawing/2014/main" id="{558B2820-9D20-A2C2-FDA9-A8510F9A0684}"/>
              </a:ext>
            </a:extLst>
          </p:cNvPr>
          <p:cNvSpPr/>
          <p:nvPr/>
        </p:nvSpPr>
        <p:spPr>
          <a:xfrm>
            <a:off x="2987249" y="6811185"/>
            <a:ext cx="1211041" cy="706709"/>
          </a:xfrm>
          <a:prstGeom prst="round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88" b="1" dirty="0">
                <a:solidFill>
                  <a:schemeClr val="tx1"/>
                </a:solidFill>
              </a:rPr>
              <a:t>End of Treatment (EOT)</a:t>
            </a:r>
          </a:p>
          <a:p>
            <a:pPr algn="ctr"/>
            <a:r>
              <a:rPr lang="en-US" sz="675" dirty="0">
                <a:solidFill>
                  <a:schemeClr val="tx1"/>
                </a:solidFill>
              </a:rPr>
              <a:t>32 out of 37 Tested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25 POS</a:t>
            </a:r>
          </a:p>
          <a:p>
            <a:pPr marL="160734" indent="-160734" algn="ctr">
              <a:buFontTx/>
              <a:buChar char="-"/>
            </a:pPr>
            <a:r>
              <a:rPr lang="en-US" sz="675" dirty="0">
                <a:solidFill>
                  <a:schemeClr val="tx1"/>
                </a:solidFill>
              </a:rPr>
              <a:t>7 NEG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BC6CD5C7-22E4-6A3F-CA71-FB4D2C5E90BC}"/>
              </a:ext>
            </a:extLst>
          </p:cNvPr>
          <p:cNvCxnSpPr>
            <a:cxnSpLocks/>
            <a:endCxn id="7" idx="0"/>
          </p:cNvCxnSpPr>
          <p:nvPr/>
        </p:nvCxnSpPr>
        <p:spPr>
          <a:xfrm>
            <a:off x="2237992" y="5893494"/>
            <a:ext cx="0" cy="91769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FFD7A6AD-431A-B6EE-9370-2EEC0D1387D6}"/>
              </a:ext>
            </a:extLst>
          </p:cNvPr>
          <p:cNvCxnSpPr>
            <a:cxnSpLocks/>
            <a:stCxn id="6" idx="2"/>
            <a:endCxn id="50" idx="0"/>
          </p:cNvCxnSpPr>
          <p:nvPr/>
        </p:nvCxnSpPr>
        <p:spPr>
          <a:xfrm>
            <a:off x="3592769" y="6706725"/>
            <a:ext cx="1" cy="10446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C7D9360B-8AF3-41A4-290B-22C8C2849FEE}"/>
              </a:ext>
            </a:extLst>
          </p:cNvPr>
          <p:cNvSpPr txBox="1"/>
          <p:nvPr/>
        </p:nvSpPr>
        <p:spPr>
          <a:xfrm>
            <a:off x="277693" y="4224921"/>
            <a:ext cx="3466013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solidFill>
                  <a:srgbClr val="000000"/>
                </a:solidFill>
                <a:latin typeface="Calibri" panose="020F0502020204030204" pitchFamily="34" charset="0"/>
              </a:rPr>
              <a:t>Figure S2. MALDI-TOF tests and results in the trial population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​</a:t>
            </a:r>
            <a:endParaRPr lang="en-US" sz="1013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B734475-CE62-6914-1DDE-7912DE1D00BC}"/>
              </a:ext>
            </a:extLst>
          </p:cNvPr>
          <p:cNvSpPr txBox="1"/>
          <p:nvPr/>
        </p:nvSpPr>
        <p:spPr>
          <a:xfrm>
            <a:off x="252772" y="7810124"/>
            <a:ext cx="6367398" cy="2482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13" b="1" dirty="0">
                <a:solidFill>
                  <a:srgbClr val="000000"/>
                </a:solidFill>
                <a:latin typeface="Calibri" panose="020F0502020204030204" pitchFamily="34" charset="0"/>
              </a:rPr>
              <a:t>Abbreviations:</a:t>
            </a:r>
            <a:r>
              <a:rPr lang="en-US" sz="1013" dirty="0">
                <a:solidFill>
                  <a:srgbClr val="000000"/>
                </a:solidFill>
                <a:latin typeface="Calibri" panose="020F0502020204030204" pitchFamily="34" charset="0"/>
              </a:rPr>
              <a:t> MALDI-TOF, matrix-assisted laser desorption/ionization time of flight; POS, positive; NEG, negative.​</a:t>
            </a:r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15774529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8F5AB77-CBCA-575D-B2AD-AE70E2ABAA84}"/>
              </a:ext>
            </a:extLst>
          </p:cNvPr>
          <p:cNvSpPr txBox="1"/>
          <p:nvPr/>
        </p:nvSpPr>
        <p:spPr>
          <a:xfrm>
            <a:off x="766" y="4192411"/>
            <a:ext cx="6686550" cy="363690"/>
          </a:xfrm>
          <a:prstGeom prst="rect">
            <a:avLst/>
          </a:prstGeom>
          <a:noFill/>
        </p:spPr>
        <p:txBody>
          <a:bodyPr wrap="square" lIns="51435" tIns="25718" rIns="51435" bIns="25718" rtlCol="0" anchor="t">
            <a:spAutoFit/>
          </a:bodyPr>
          <a:lstStyle/>
          <a:p>
            <a:r>
              <a:rPr lang="en-US" sz="1013" b="1" dirty="0">
                <a:latin typeface="Calibri"/>
                <a:ea typeface="Calibri"/>
                <a:cs typeface="Calibri"/>
              </a:rPr>
              <a:t>Figure S3. Correlation of MALDI-TOF and SPEP M protein quantification.</a:t>
            </a:r>
            <a:endParaRPr lang="en-US" sz="1013" dirty="0">
              <a:ea typeface="Calibri"/>
              <a:cs typeface="Calibri"/>
            </a:endParaRPr>
          </a:p>
          <a:p>
            <a:endParaRPr lang="en-US" sz="1013" b="1" dirty="0">
              <a:ea typeface="Calibri"/>
              <a:cs typeface="Calibri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23D5FB-358E-B165-F9B7-28441470E4AB}"/>
              </a:ext>
            </a:extLst>
          </p:cNvPr>
          <p:cNvSpPr txBox="1"/>
          <p:nvPr/>
        </p:nvSpPr>
        <p:spPr>
          <a:xfrm>
            <a:off x="292244" y="7661131"/>
            <a:ext cx="6504708" cy="51956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51435" tIns="25718" rIns="51435" bIns="2571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13" b="1" dirty="0">
                <a:latin typeface="Calibri"/>
                <a:ea typeface="Calibri"/>
                <a:cs typeface="Calibri"/>
              </a:rPr>
              <a:t>Abbreviations: </a:t>
            </a:r>
            <a:r>
              <a:rPr lang="en-US" sz="1013" dirty="0">
                <a:latin typeface="Calibri"/>
                <a:ea typeface="Calibri"/>
                <a:cs typeface="Calibri"/>
              </a:rPr>
              <a:t>MALDI-TOF, matrix-assisted laser desorption/ionization time of flight; SPEP, serum protein electrophoresis.</a:t>
            </a:r>
          </a:p>
          <a:p>
            <a:pPr algn="l"/>
            <a:endParaRPr lang="en-US" sz="1013" dirty="0">
              <a:ea typeface="Calibri"/>
              <a:cs typeface="Calibri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D1EF4D7-BBBA-3EED-CC1F-65109EA74B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63" y="4985177"/>
            <a:ext cx="6772275" cy="22270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84244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B27B6DF-6569-C0D3-ECFA-BD917B6146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087" y="4874483"/>
            <a:ext cx="6410105" cy="18821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046D8A-10BA-829C-FD9E-65063F3B3B46}"/>
              </a:ext>
            </a:extLst>
          </p:cNvPr>
          <p:cNvSpPr txBox="1"/>
          <p:nvPr/>
        </p:nvSpPr>
        <p:spPr>
          <a:xfrm>
            <a:off x="72422" y="4224921"/>
            <a:ext cx="3995004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b="1" dirty="0">
                <a:solidFill>
                  <a:srgbClr val="000000"/>
                </a:solidFill>
                <a:latin typeface="Calibri" panose="020F0502020204030204" pitchFamily="34" charset="0"/>
              </a:rPr>
              <a:t>Figure S4. Progression-free survival by MALDI-TOF result at C9 and EOT</a:t>
            </a:r>
            <a:endParaRPr lang="en-US" sz="1013" dirty="0"/>
          </a:p>
        </p:txBody>
      </p:sp>
    </p:spTree>
    <p:extLst>
      <p:ext uri="{BB962C8B-B14F-4D97-AF65-F5344CB8AC3E}">
        <p14:creationId xmlns:p14="http://schemas.microsoft.com/office/powerpoint/2010/main" val="3620536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617</TotalTime>
  <Words>200</Words>
  <Application>Microsoft Macintosh PowerPoint</Application>
  <PresentationFormat>Widescreen</PresentationFormat>
  <Paragraphs>35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Office 2013 - 2022 Theme</vt:lpstr>
      <vt:lpstr>Supplementary Figur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hobrial, Irene M.,MD</dc:creator>
  <cp:lastModifiedBy>Aranha, Michelle P.</cp:lastModifiedBy>
  <cp:revision>440</cp:revision>
  <cp:lastPrinted>2024-04-08T22:05:26Z</cp:lastPrinted>
  <dcterms:created xsi:type="dcterms:W3CDTF">2024-01-22T01:16:38Z</dcterms:created>
  <dcterms:modified xsi:type="dcterms:W3CDTF">2024-04-12T11:54:38Z</dcterms:modified>
</cp:coreProperties>
</file>